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BDE9B"/>
    <a:srgbClr val="5D8ED5"/>
    <a:srgbClr val="9348C5"/>
    <a:srgbClr val="FF3C8D"/>
    <a:srgbClr val="FF52D7"/>
    <a:srgbClr val="FF9275"/>
    <a:srgbClr val="FFA983"/>
    <a:srgbClr val="D1C761"/>
    <a:srgbClr val="C0D065"/>
    <a:srgbClr val="E0ADE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3"/>
    <p:restoredTop sz="94628"/>
  </p:normalViewPr>
  <p:slideViewPr>
    <p:cSldViewPr snapToGrid="0">
      <p:cViewPr varScale="1">
        <p:scale>
          <a:sx n="90" d="100"/>
          <a:sy n="90" d="100"/>
        </p:scale>
        <p:origin x="232" y="3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145549-7991-6AF8-2733-E6B7B81D8A0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D84CF5E-DEDB-C298-C382-876CAB76603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50101E-5132-440E-25B4-81907BEDF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EF3EE-6207-B148-B558-E77696A44B5B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BF0808-46EA-C44D-FC8B-1B38DF391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9CB72C-C1F6-612A-8E25-EF3316EEB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D6C6-1200-6348-9546-B70EE07B6A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727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BB4C8D-2BE0-E0CB-3962-D95C714C82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332B6E-9989-8295-AADA-D99CC2697B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BDF6A3-5004-6EAB-9314-6A3396DC8D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EF3EE-6207-B148-B558-E77696A44B5B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EB71FA-31C9-03BB-5083-D599A5F3E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75B3C8-FBC8-96CB-A077-954E95680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D6C6-1200-6348-9546-B70EE07B6A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538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72CB6AC-4A2F-7B11-9C6A-885EFDC961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E57CA0-6887-8B46-E1C1-D3DD94540D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C3B525-5BC1-27E7-C53F-A98FF6670F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EF3EE-6207-B148-B558-E77696A44B5B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476B0F-AF45-CEB2-8C68-9C6F200701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711887-77BA-AA39-F3C6-BEE591FB90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D6C6-1200-6348-9546-B70EE07B6A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8723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C5FE6A-8D6D-53EE-348E-8A8C43F7B2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9CDD22-11AB-B18A-953E-E90CD7D166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7EFCF3-1227-80D5-715A-36C124280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EF3EE-6207-B148-B558-E77696A44B5B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83D467-A595-32F8-4B7D-A0AF1A1CE9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FDFF45-580C-C7E1-183A-FE632C683B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D6C6-1200-6348-9546-B70EE07B6A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24870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70D36E-FEA3-7377-51AF-DD86F0527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29CE75-69DA-DB3F-BCBD-8099848C8B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161A57-E030-1950-0C96-80AF011933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EF3EE-6207-B148-B558-E77696A44B5B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487DF6-164A-EB2B-4782-E10ED043E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94B104-0047-D8C5-0BEC-8E00C565D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D6C6-1200-6348-9546-B70EE07B6A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850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92E8A8-01DE-0EDB-DF94-4E97261FBE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F6ED09-E744-CEA8-DC79-277EF89A9B4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11D32B-A520-11C0-33AD-B77DB4B2C6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5EDD58-4234-5D72-4E76-1B2AED999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EF3EE-6207-B148-B558-E77696A44B5B}" type="datetimeFigureOut">
              <a:rPr lang="en-US" smtClean="0"/>
              <a:t>7/1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70CDF8-57F3-3B12-3D6C-AD93D84CC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82ED4A-3BC1-59A2-0231-85A6674FF0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D6C6-1200-6348-9546-B70EE07B6A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321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6C20C4-80BE-748E-8490-7C2B949941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4FC5E5-4B1C-4B9F-8292-BF05A76F51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B8FCE9A-113B-5A4D-ADD9-51CBF67DB9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79B71D8-2D6D-4C7A-98AB-72A5C9969D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FCA80E6-7A45-605E-DE85-9F731AC652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1651E06-39D8-221D-9499-636F0710EF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EF3EE-6207-B148-B558-E77696A44B5B}" type="datetimeFigureOut">
              <a:rPr lang="en-US" smtClean="0"/>
              <a:t>7/19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BC657CD-45D5-F231-020A-FFB530A977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283046C-9C1C-5DDC-45FD-0665167875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D6C6-1200-6348-9546-B70EE07B6A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502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9D2442-10C5-3D25-5C7C-611DA17B02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3C88B57-E668-BAE6-5170-90C0BF8364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EF3EE-6207-B148-B558-E77696A44B5B}" type="datetimeFigureOut">
              <a:rPr lang="en-US" smtClean="0"/>
              <a:t>7/19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F7DB150-CBAD-9147-DCF4-D9B0276735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22A9353-07A8-03D9-56EB-4033081977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D6C6-1200-6348-9546-B70EE07B6A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4222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C3C0581-F563-60B0-1438-44F97AC2A5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EF3EE-6207-B148-B558-E77696A44B5B}" type="datetimeFigureOut">
              <a:rPr lang="en-US" smtClean="0"/>
              <a:t>7/19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923D96E-6880-747C-EB1E-AEDC9DD12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EE8B111-BF59-BECF-3FAF-0179ACB8D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D6C6-1200-6348-9546-B70EE07B6A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1472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2352EF-1512-EA4D-037E-DC1C7930F4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229DD1-8B7A-2032-2C65-AFDA14946F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58D1C7-B0AF-457A-F429-83C314775E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7F1B6F-4B0E-8EE9-7F37-C318B9AE95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EF3EE-6207-B148-B558-E77696A44B5B}" type="datetimeFigureOut">
              <a:rPr lang="en-US" smtClean="0"/>
              <a:t>7/1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DF6278-71D5-6F52-40EA-03EACE3F8E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970BFB-F1E9-20DE-581A-ABB8CBBCB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D6C6-1200-6348-9546-B70EE07B6A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0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B5CA90-6C36-ED00-1D29-66AAB10C81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5A91B5E-B40B-90A6-132A-42AE630BFB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007D48-73D4-7AF3-F790-EC0286AB24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0A4CB1-AB95-4C09-155E-4B9B20A0E9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EF3EE-6207-B148-B558-E77696A44B5B}" type="datetimeFigureOut">
              <a:rPr lang="en-US" smtClean="0"/>
              <a:t>7/1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775EF4-87EC-F946-EB61-4F40A62238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82746F-1CB7-DCB9-E267-1DEC88DA1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D6C6-1200-6348-9546-B70EE07B6A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562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24DFB43-F2C3-5109-3F01-4082D1A34E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22C5B2-68AE-DF5C-9BA2-B7C1AFFBB2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40A4EE-1569-0E78-4A27-3C038C86E36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BEF3EE-6207-B148-B558-E77696A44B5B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3C8E87-52AD-F320-99A5-8FA8284293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6F5720-9220-C3DC-DD81-30C81C7932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5D6C6-1200-6348-9546-B70EE07B6A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6145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svg"/><Relationship Id="rId18" Type="http://schemas.openxmlformats.org/officeDocument/2006/relationships/image" Target="../media/image17.pn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12" Type="http://schemas.openxmlformats.org/officeDocument/2006/relationships/image" Target="../media/image11.png"/><Relationship Id="rId17" Type="http://schemas.openxmlformats.org/officeDocument/2006/relationships/image" Target="../media/image16.sv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svg"/><Relationship Id="rId5" Type="http://schemas.openxmlformats.org/officeDocument/2006/relationships/image" Target="../media/image4.svg"/><Relationship Id="rId15" Type="http://schemas.openxmlformats.org/officeDocument/2006/relationships/image" Target="../media/image14.sv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sv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Rectangle 36">
            <a:extLst>
              <a:ext uri="{FF2B5EF4-FFF2-40B4-BE49-F238E27FC236}">
                <a16:creationId xmlns:a16="http://schemas.microsoft.com/office/drawing/2014/main" id="{812BDE24-FF44-AB4D-6B88-6A13000DCE93}"/>
              </a:ext>
            </a:extLst>
          </p:cNvPr>
          <p:cNvSpPr/>
          <p:nvPr/>
        </p:nvSpPr>
        <p:spPr>
          <a:xfrm>
            <a:off x="196841" y="1645336"/>
            <a:ext cx="11736475" cy="228783"/>
          </a:xfrm>
          <a:prstGeom prst="rect">
            <a:avLst/>
          </a:prstGeom>
          <a:solidFill>
            <a:srgbClr val="0070C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76A45C6E-D5E0-A9C1-DF8F-D3B5BC46D419}"/>
              </a:ext>
            </a:extLst>
          </p:cNvPr>
          <p:cNvSpPr/>
          <p:nvPr/>
        </p:nvSpPr>
        <p:spPr>
          <a:xfrm>
            <a:off x="3841482" y="2544195"/>
            <a:ext cx="3163152" cy="3113326"/>
          </a:xfrm>
          <a:prstGeom prst="ellipse">
            <a:avLst/>
          </a:prstGeom>
          <a:solidFill>
            <a:srgbClr val="E0ADE5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8C89148-1159-1599-4D9B-3D5125B2A87F}"/>
              </a:ext>
            </a:extLst>
          </p:cNvPr>
          <p:cNvSpPr/>
          <p:nvPr/>
        </p:nvSpPr>
        <p:spPr>
          <a:xfrm>
            <a:off x="196841" y="1951105"/>
            <a:ext cx="3502474" cy="4138713"/>
          </a:xfrm>
          <a:prstGeom prst="rect">
            <a:avLst/>
          </a:prstGeom>
          <a:solidFill>
            <a:srgbClr val="9348C5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C282715-90F9-DDD5-9366-4E06F0F49FEC}"/>
              </a:ext>
            </a:extLst>
          </p:cNvPr>
          <p:cNvSpPr/>
          <p:nvPr/>
        </p:nvSpPr>
        <p:spPr>
          <a:xfrm>
            <a:off x="7105704" y="1914388"/>
            <a:ext cx="2372498" cy="1821464"/>
          </a:xfrm>
          <a:prstGeom prst="rect">
            <a:avLst/>
          </a:prstGeom>
          <a:solidFill>
            <a:srgbClr val="5D8ED5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D1B2252-1C17-5F4C-8E2F-0A7E3730AA97}"/>
              </a:ext>
            </a:extLst>
          </p:cNvPr>
          <p:cNvSpPr/>
          <p:nvPr/>
        </p:nvSpPr>
        <p:spPr>
          <a:xfrm>
            <a:off x="7118584" y="3886735"/>
            <a:ext cx="4856208" cy="637301"/>
          </a:xfrm>
          <a:prstGeom prst="rect">
            <a:avLst/>
          </a:prstGeom>
          <a:solidFill>
            <a:srgbClr val="FF9275"/>
          </a:solidFill>
          <a:ln>
            <a:solidFill>
              <a:schemeClr val="accent4">
                <a:lumMod val="60000"/>
                <a:lumOff val="40000"/>
                <a:alpha val="12549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6D51BC0-C6CE-BF15-DFA3-7970F24A7380}"/>
              </a:ext>
            </a:extLst>
          </p:cNvPr>
          <p:cNvSpPr/>
          <p:nvPr/>
        </p:nvSpPr>
        <p:spPr>
          <a:xfrm>
            <a:off x="9565750" y="1905141"/>
            <a:ext cx="2372498" cy="1821464"/>
          </a:xfrm>
          <a:prstGeom prst="rect">
            <a:avLst/>
          </a:prstGeom>
          <a:solidFill>
            <a:srgbClr val="5D8ED5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6" name="Graphic 15" descr="Medicine outline">
            <a:extLst>
              <a:ext uri="{FF2B5EF4-FFF2-40B4-BE49-F238E27FC236}">
                <a16:creationId xmlns:a16="http://schemas.microsoft.com/office/drawing/2014/main" id="{4EB3124E-001E-32F7-5253-925DF395B8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8392458" y="4730672"/>
            <a:ext cx="679559" cy="679559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08A4F069-0920-9A21-E520-5BA9C250ECA0}"/>
              </a:ext>
            </a:extLst>
          </p:cNvPr>
          <p:cNvSpPr txBox="1"/>
          <p:nvPr/>
        </p:nvSpPr>
        <p:spPr>
          <a:xfrm>
            <a:off x="1193062" y="3155624"/>
            <a:ext cx="2132702" cy="83099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solidFill>
                  <a:schemeClr val="bg1"/>
                </a:solidFill>
                <a:latin typeface="Avenir Book" panose="02000503020000020003" pitchFamily="2" charset="0"/>
              </a:rPr>
              <a:t>Adult patients who have </a:t>
            </a:r>
            <a:r>
              <a:rPr lang="en-US" sz="1600" u="sng" dirty="0">
                <a:solidFill>
                  <a:schemeClr val="bg1"/>
                </a:solidFill>
                <a:latin typeface="Avenir Book" panose="02000503020000020003" pitchFamily="2" charset="0"/>
              </a:rPr>
              <a:t>not</a:t>
            </a:r>
            <a:r>
              <a:rPr lang="en-US" sz="1600" dirty="0">
                <a:solidFill>
                  <a:schemeClr val="bg1"/>
                </a:solidFill>
                <a:latin typeface="Avenir Book" panose="02000503020000020003" pitchFamily="2" charset="0"/>
              </a:rPr>
              <a:t> had cardiac surgery</a:t>
            </a:r>
          </a:p>
        </p:txBody>
      </p:sp>
      <p:pic>
        <p:nvPicPr>
          <p:cNvPr id="20" name="Graphic 19" descr="Heart with pulse outline">
            <a:extLst>
              <a:ext uri="{FF2B5EF4-FFF2-40B4-BE49-F238E27FC236}">
                <a16:creationId xmlns:a16="http://schemas.microsoft.com/office/drawing/2014/main" id="{EA5BA1A2-8EAE-A29A-FBC0-2B048CD45E1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8563802" y="2029231"/>
            <a:ext cx="914400" cy="91440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5F761EEE-1E9A-5C0C-71B0-ADE2578C1A79}"/>
              </a:ext>
            </a:extLst>
          </p:cNvPr>
          <p:cNvSpPr txBox="1"/>
          <p:nvPr/>
        </p:nvSpPr>
        <p:spPr>
          <a:xfrm>
            <a:off x="4388479" y="3155624"/>
            <a:ext cx="21012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Avenir Book" panose="02000503020000020003" pitchFamily="2" charset="0"/>
              </a:rPr>
              <a:t>5 </a:t>
            </a:r>
            <a:r>
              <a:rPr lang="en-US" sz="2000" dirty="0">
                <a:latin typeface="Avenir Book" panose="02000503020000020003" pitchFamily="2" charset="0"/>
              </a:rPr>
              <a:t>Randomized Control Trial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F48B484-7AF7-6CB7-70AB-B5DFCCC10514}"/>
              </a:ext>
            </a:extLst>
          </p:cNvPr>
          <p:cNvSpPr txBox="1"/>
          <p:nvPr/>
        </p:nvSpPr>
        <p:spPr>
          <a:xfrm>
            <a:off x="4388479" y="4262426"/>
            <a:ext cx="210122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Avenir Book" panose="02000503020000020003" pitchFamily="2" charset="0"/>
              </a:rPr>
              <a:t>4713 </a:t>
            </a:r>
            <a:r>
              <a:rPr lang="en-US" sz="2000" dirty="0">
                <a:latin typeface="Avenir Book" panose="02000503020000020003" pitchFamily="2" charset="0"/>
              </a:rPr>
              <a:t>patients</a:t>
            </a:r>
            <a:endParaRPr lang="en-US" sz="2800" b="1" dirty="0">
              <a:latin typeface="Avenir Book" panose="02000503020000020003" pitchFamily="2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1490C09-8DA5-79B0-9D47-2B3098450A3B}"/>
              </a:ext>
            </a:extLst>
          </p:cNvPr>
          <p:cNvSpPr txBox="1"/>
          <p:nvPr/>
        </p:nvSpPr>
        <p:spPr>
          <a:xfrm>
            <a:off x="7101093" y="2030418"/>
            <a:ext cx="163114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solidFill>
                  <a:schemeClr val="bg1"/>
                </a:solidFill>
                <a:latin typeface="Avenir Book" panose="02000503020000020003" pitchFamily="2" charset="0"/>
              </a:rPr>
              <a:t>No difference in incidence of atrial fibrillatio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668F4E7-9BA8-DDFB-760B-2A6C631EBD55}"/>
              </a:ext>
            </a:extLst>
          </p:cNvPr>
          <p:cNvSpPr txBox="1"/>
          <p:nvPr/>
        </p:nvSpPr>
        <p:spPr>
          <a:xfrm>
            <a:off x="7118584" y="2858045"/>
            <a:ext cx="2372498" cy="83099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  <a:latin typeface="Avenir Book" panose="02000503020000020003" pitchFamily="2" charset="0"/>
              </a:rPr>
              <a:t>OR 0.72, [95% CI 0.48 to 1.09]</a:t>
            </a:r>
          </a:p>
        </p:txBody>
      </p:sp>
      <p:pic>
        <p:nvPicPr>
          <p:cNvPr id="28" name="Graphic 27" descr="Bar graph with downward trend outline">
            <a:extLst>
              <a:ext uri="{FF2B5EF4-FFF2-40B4-BE49-F238E27FC236}">
                <a16:creationId xmlns:a16="http://schemas.microsoft.com/office/drawing/2014/main" id="{CF528E34-A67B-14C8-82A5-8428108F5F5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1010973" y="2800267"/>
            <a:ext cx="914400" cy="914400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3C2CF919-8A17-BA00-6E81-89B5DAA99AE7}"/>
              </a:ext>
            </a:extLst>
          </p:cNvPr>
          <p:cNvSpPr txBox="1"/>
          <p:nvPr/>
        </p:nvSpPr>
        <p:spPr>
          <a:xfrm>
            <a:off x="9670787" y="2086456"/>
            <a:ext cx="1378812" cy="1477328"/>
          </a:xfrm>
          <a:prstGeom prst="rect">
            <a:avLst/>
          </a:prstGeom>
          <a:solidFill>
            <a:srgbClr val="5D8ED5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Avenir Book" panose="02000503020000020003" pitchFamily="2" charset="0"/>
              </a:rPr>
              <a:t>High risk of bias and very low certainty of results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5C961AD-406A-5294-7105-94E4576C5131}"/>
              </a:ext>
            </a:extLst>
          </p:cNvPr>
          <p:cNvSpPr txBox="1"/>
          <p:nvPr/>
        </p:nvSpPr>
        <p:spPr>
          <a:xfrm>
            <a:off x="7279434" y="4020461"/>
            <a:ext cx="44659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venir Book" panose="02000503020000020003" pitchFamily="2" charset="0"/>
              </a:rPr>
              <a:t>No studies in critically ill patients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A314938F-9AC0-8F45-1377-393EF8B457BE}"/>
              </a:ext>
            </a:extLst>
          </p:cNvPr>
          <p:cNvSpPr/>
          <p:nvPr/>
        </p:nvSpPr>
        <p:spPr>
          <a:xfrm>
            <a:off x="7118584" y="4684166"/>
            <a:ext cx="4856208" cy="1409074"/>
          </a:xfrm>
          <a:prstGeom prst="rect">
            <a:avLst/>
          </a:prstGeom>
          <a:solidFill>
            <a:srgbClr val="FF3C8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3" name="Graphic 32" descr="Lungs outline">
            <a:extLst>
              <a:ext uri="{FF2B5EF4-FFF2-40B4-BE49-F238E27FC236}">
                <a16:creationId xmlns:a16="http://schemas.microsoft.com/office/drawing/2014/main" id="{9DCB3760-F953-8EB1-9733-860BC0F6B70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7279434" y="4915582"/>
            <a:ext cx="841246" cy="841246"/>
          </a:xfrm>
          <a:prstGeom prst="rect">
            <a:avLst/>
          </a:prstGeom>
        </p:spPr>
      </p:pic>
      <p:sp>
        <p:nvSpPr>
          <p:cNvPr id="34" name="Title 1">
            <a:extLst>
              <a:ext uri="{FF2B5EF4-FFF2-40B4-BE49-F238E27FC236}">
                <a16:creationId xmlns:a16="http://schemas.microsoft.com/office/drawing/2014/main" id="{1144AA8F-CE7B-5C2B-EF00-D209BA488CA9}"/>
              </a:ext>
            </a:extLst>
          </p:cNvPr>
          <p:cNvSpPr txBox="1">
            <a:spLocks/>
          </p:cNvSpPr>
          <p:nvPr/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D045C6E-E23F-3D55-A2AC-1A4C77C6F939}"/>
              </a:ext>
            </a:extLst>
          </p:cNvPr>
          <p:cNvSpPr txBox="1"/>
          <p:nvPr/>
        </p:nvSpPr>
        <p:spPr>
          <a:xfrm>
            <a:off x="133011" y="88115"/>
            <a:ext cx="11790441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00" dirty="0">
                <a:latin typeface="Avenir Book" panose="02000503020000020003" pitchFamily="2" charset="0"/>
                <a:ea typeface="Apple Symbols" panose="02000000000000000000" pitchFamily="2" charset="-79"/>
                <a:cs typeface="Al Nile" pitchFamily="2" charset="-78"/>
              </a:rPr>
              <a:t>Does the use of magnesium supplementation </a:t>
            </a:r>
          </a:p>
          <a:p>
            <a:r>
              <a:rPr lang="en-US" sz="2800" dirty="0">
                <a:latin typeface="Avenir Book" panose="02000503020000020003" pitchFamily="2" charset="0"/>
                <a:ea typeface="Apple Symbols" panose="02000000000000000000" pitchFamily="2" charset="-79"/>
                <a:cs typeface="Al Nile" pitchFamily="2" charset="-78"/>
              </a:rPr>
              <a:t>prevent the development of atrial fibrillation </a:t>
            </a:r>
          </a:p>
          <a:p>
            <a:r>
              <a:rPr lang="en-US" sz="2800" dirty="0">
                <a:latin typeface="Avenir Book" panose="02000503020000020003" pitchFamily="2" charset="0"/>
                <a:ea typeface="Apple Symbols" panose="02000000000000000000" pitchFamily="2" charset="-79"/>
                <a:cs typeface="Al Nile" pitchFamily="2" charset="-78"/>
              </a:rPr>
              <a:t>in non-cardiac surgery patients?</a:t>
            </a:r>
          </a:p>
        </p:txBody>
      </p:sp>
      <p:pic>
        <p:nvPicPr>
          <p:cNvPr id="39" name="Graphic 38" descr="Inpatient outline">
            <a:extLst>
              <a:ext uri="{FF2B5EF4-FFF2-40B4-BE49-F238E27FC236}">
                <a16:creationId xmlns:a16="http://schemas.microsoft.com/office/drawing/2014/main" id="{5FE692EB-033F-9FD6-5FBE-BFC14011B41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278662" y="3035099"/>
            <a:ext cx="914400" cy="914400"/>
          </a:xfrm>
          <a:prstGeom prst="rect">
            <a:avLst/>
          </a:prstGeom>
        </p:spPr>
      </p:pic>
      <p:pic>
        <p:nvPicPr>
          <p:cNvPr id="41" name="Graphic 40" descr="Document outline">
            <a:extLst>
              <a:ext uri="{FF2B5EF4-FFF2-40B4-BE49-F238E27FC236}">
                <a16:creationId xmlns:a16="http://schemas.microsoft.com/office/drawing/2014/main" id="{5F9A73A4-540C-F16D-A2B9-268AA8617194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353596" y="2101025"/>
            <a:ext cx="740109" cy="740109"/>
          </a:xfrm>
          <a:prstGeom prst="rect">
            <a:avLst/>
          </a:prstGeom>
        </p:spPr>
      </p:pic>
      <p:pic>
        <p:nvPicPr>
          <p:cNvPr id="45" name="Graphic 44" descr="Heartbeat outline">
            <a:extLst>
              <a:ext uri="{FF2B5EF4-FFF2-40B4-BE49-F238E27FC236}">
                <a16:creationId xmlns:a16="http://schemas.microsoft.com/office/drawing/2014/main" id="{31F15773-C579-4F04-F8DD-16272E5201D4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298909" y="5012949"/>
            <a:ext cx="914400" cy="914400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F525FA51-6FD1-0A79-AE05-01C9429B1600}"/>
              </a:ext>
            </a:extLst>
          </p:cNvPr>
          <p:cNvSpPr txBox="1"/>
          <p:nvPr/>
        </p:nvSpPr>
        <p:spPr>
          <a:xfrm>
            <a:off x="1259912" y="2189366"/>
            <a:ext cx="196557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  <a:latin typeface="Avenir Book" panose="02000503020000020003" pitchFamily="2" charset="0"/>
              </a:rPr>
              <a:t>Systematic review and meta-analysis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9CD0D69-CC8D-5EB6-1F34-2F83436021DD}"/>
              </a:ext>
            </a:extLst>
          </p:cNvPr>
          <p:cNvSpPr txBox="1"/>
          <p:nvPr/>
        </p:nvSpPr>
        <p:spPr>
          <a:xfrm>
            <a:off x="1131770" y="4274116"/>
            <a:ext cx="2132702" cy="58477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solidFill>
                  <a:schemeClr val="bg1"/>
                </a:solidFill>
                <a:latin typeface="Avenir Book" panose="02000503020000020003" pitchFamily="2" charset="0"/>
              </a:rPr>
              <a:t>Magnesium versus placebo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D31F577-61A3-059A-C663-0EC52EB42006}"/>
              </a:ext>
            </a:extLst>
          </p:cNvPr>
          <p:cNvSpPr txBox="1"/>
          <p:nvPr/>
        </p:nvSpPr>
        <p:spPr>
          <a:xfrm>
            <a:off x="1131770" y="5191140"/>
            <a:ext cx="2132702" cy="58477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solidFill>
                  <a:schemeClr val="bg1"/>
                </a:solidFill>
                <a:latin typeface="Avenir Book" panose="02000503020000020003" pitchFamily="2" charset="0"/>
              </a:rPr>
              <a:t>Development of atrial fibrillation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64A2C92F-20EC-A197-1212-03E3BFC7204E}"/>
              </a:ext>
            </a:extLst>
          </p:cNvPr>
          <p:cNvSpPr/>
          <p:nvPr/>
        </p:nvSpPr>
        <p:spPr>
          <a:xfrm>
            <a:off x="196841" y="6146022"/>
            <a:ext cx="11777951" cy="189357"/>
          </a:xfrm>
          <a:prstGeom prst="rect">
            <a:avLst/>
          </a:prstGeom>
          <a:solidFill>
            <a:srgbClr val="0070C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1" name="Graphic 50" descr="IV outline">
            <a:extLst>
              <a:ext uri="{FF2B5EF4-FFF2-40B4-BE49-F238E27FC236}">
                <a16:creationId xmlns:a16="http://schemas.microsoft.com/office/drawing/2014/main" id="{6264B8F8-394E-1F45-B6E9-6A974EB834E5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96DAC541-7B7A-43D3-8B79-37D633B846F1}">
                <asvg:svgBlip xmlns:asvg="http://schemas.microsoft.com/office/drawing/2016/SVG/main" r:embed="rId17"/>
              </a:ext>
            </a:extLst>
          </a:blip>
          <a:stretch>
            <a:fillRect/>
          </a:stretch>
        </p:blipFill>
        <p:spPr>
          <a:xfrm>
            <a:off x="298909" y="4103557"/>
            <a:ext cx="853188" cy="853188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0E76FF5D-BF87-A84E-204B-7D3A0FC0B94C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0283194" y="105181"/>
            <a:ext cx="1631145" cy="1473292"/>
          </a:xfrm>
          <a:prstGeom prst="rect">
            <a:avLst/>
          </a:prstGeom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id="{CF60E6A7-5B98-2A10-B074-93B9FB3627EA}"/>
              </a:ext>
            </a:extLst>
          </p:cNvPr>
          <p:cNvSpPr txBox="1"/>
          <p:nvPr/>
        </p:nvSpPr>
        <p:spPr>
          <a:xfrm>
            <a:off x="8244762" y="4836458"/>
            <a:ext cx="350063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chemeClr val="bg1"/>
                </a:solidFill>
                <a:latin typeface="Avenir Book" panose="02000503020000020003" pitchFamily="2" charset="0"/>
              </a:rPr>
              <a:t>Magnesium may be beneficial in certain subgroups, such as those undergoing thoracic surgery</a:t>
            </a:r>
          </a:p>
        </p:txBody>
      </p:sp>
    </p:spTree>
    <p:extLst>
      <p:ext uri="{BB962C8B-B14F-4D97-AF65-F5344CB8AC3E}">
        <p14:creationId xmlns:p14="http://schemas.microsoft.com/office/powerpoint/2010/main" val="19369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0</TotalTime>
  <Words>90</Words>
  <Application>Microsoft Macintosh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venir Book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bley, Stephanie</dc:creator>
  <cp:lastModifiedBy>Stephanie Sibley</cp:lastModifiedBy>
  <cp:revision>1</cp:revision>
  <dcterms:created xsi:type="dcterms:W3CDTF">2023-07-19T15:56:00Z</dcterms:created>
  <dcterms:modified xsi:type="dcterms:W3CDTF">2023-07-20T13:16:22Z</dcterms:modified>
</cp:coreProperties>
</file>